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3" r:id="rId2"/>
  </p:sldIdLst>
  <p:sldSz cx="9601200" cy="12801600" type="A3"/>
  <p:notesSz cx="6858000" cy="9296400"/>
  <p:defaultTextStyle>
    <a:defPPr>
      <a:defRPr lang="en-US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xel de Zelicourt" initials="Zely" lastIdx="2" clrIdx="0"/>
  <p:cmAuthor id="1" name="KITS" initials="K" lastIdx="3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86" autoAdjust="0"/>
    <p:restoredTop sz="94660"/>
  </p:normalViewPr>
  <p:slideViewPr>
    <p:cSldViewPr>
      <p:cViewPr varScale="1">
        <p:scale>
          <a:sx n="63" d="100"/>
          <a:sy n="63" d="100"/>
        </p:scale>
        <p:origin x="-3546" y="-13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3976796"/>
            <a:ext cx="8161020" cy="274404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962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079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60870" y="512660"/>
            <a:ext cx="2160270" cy="1092284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0060" y="512660"/>
            <a:ext cx="6320790" cy="1092284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864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36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429" y="5425866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784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0060" y="2987042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80610" y="2987042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60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0061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7278" y="2865544"/>
            <a:ext cx="4243863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77278" y="4059766"/>
            <a:ext cx="4243863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722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83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23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1" y="509694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53803" y="509695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0061" y="2678855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421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1902" y="8961121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81902" y="1143846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1902" y="10019032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155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C4086-359B-4D85-BF60-B0809E600C0D}" type="datetimeFigureOut">
              <a:rPr lang="en-US" smtClean="0"/>
              <a:t>3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77640-122C-4679-936E-2E2E250A5EC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152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882123"/>
              </p:ext>
            </p:extLst>
          </p:nvPr>
        </p:nvGraphicFramePr>
        <p:xfrm>
          <a:off x="480120" y="1720280"/>
          <a:ext cx="8642349" cy="711769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834759"/>
                <a:gridCol w="2821734"/>
                <a:gridCol w="1708224"/>
                <a:gridCol w="2277632"/>
              </a:tblGrid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' to 3'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ted</a:t>
                      </a:r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ose of the prim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F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GTTTGATCCTGGCT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S </a:t>
                      </a:r>
                      <a:r>
                        <a:rPr lang="en-US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N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terial strain identification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2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GGYTACCTTGTTACGACT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22-3G56400F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TTCGTCCACGGAGAAT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564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23-3G56400R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ATTGACGTAACTGGC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54-1G0158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AGCGAAGCTGGAAT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015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55-1G0158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CCCATTGCCGGTAGCA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26-4G0125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AGCAAACCCAGTGGC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012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27-4G0125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GCCCAGACATCGGAG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88-1G80440F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GCTACGCCTGAATACC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804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89-1G80440R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GGAATCGGAGGAAGC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66-1G2773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CGAGCACTGGACAAA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277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67-1G2773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CTCAACTTCTCCACCG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45-AT2G3787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GCCAAAGTTGGTGCTC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2G378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46-AT2G3787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AACGTCCACATCGCTTGC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30-4G1342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GTGGGGCCAAAGGAT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134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31-4G1342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CCTCCTCCAGACATG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09-AT3G30775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CCCGTCTTCTCCGAA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307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10-AT3G30775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TGCTTGTTGTCCAAAG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37-AT3G5398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TCGGTTACAAGTGTGGA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539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38-AT3G5398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CCCAATGTTATCTCCTTCA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29-AT4G3780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GTTCGACCCTTCTCG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378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30-AT4G3780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TGATGGGCACATTGT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70-1G3514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TGCGAGAACGGACA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351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71-1G3514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GGTCGATCTCCGGGA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81-AT2G3903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TCTGGTCTTGCCTCCAC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2G390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82-AT2G3903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CGTCTCAAGAAAGGGGG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62-5G5119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ACGCAAACCACCTC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5G511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63-5G5119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CCGCATACTTACCCC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62-1G1326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TTTCTACGACGGGG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1326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63-1G1326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AGCTTCCCAACGTCGC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34-4G1749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GATTCTGAATTTCCC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4G174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35-4G1749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TACAGGCCACGACCA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82-1G7493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TCGACGCCGCTCAA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1G749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883-1G7493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GGCGTCAACGACTTT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18-3G55980F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GCAGACGTGTCGGTT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3G559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PCR analysi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33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19-3G55980R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CACAGTGAAGCGGAG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490" marR="9490" marT="94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0" y="9497144"/>
            <a:ext cx="9601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3 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imer table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imers used during this study</a:t>
            </a:r>
          </a:p>
        </p:txBody>
      </p:sp>
    </p:spTree>
    <p:extLst>
      <p:ext uri="{BB962C8B-B14F-4D97-AF65-F5344CB8AC3E}">
        <p14:creationId xmlns:p14="http://schemas.microsoft.com/office/powerpoint/2010/main" val="993262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16</TotalTime>
  <Words>152</Words>
  <Application>Microsoft Office PowerPoint</Application>
  <PresentationFormat>A3 (297 x 420 mm)</PresentationFormat>
  <Paragraphs>11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>KAU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de Zelicourt</dc:creator>
  <cp:lastModifiedBy>Axel de Zelicourt</cp:lastModifiedBy>
  <cp:revision>398</cp:revision>
  <cp:lastPrinted>2016-07-14T13:42:36Z</cp:lastPrinted>
  <dcterms:created xsi:type="dcterms:W3CDTF">2015-12-01T08:55:36Z</dcterms:created>
  <dcterms:modified xsi:type="dcterms:W3CDTF">2018-03-02T09:43:52Z</dcterms:modified>
</cp:coreProperties>
</file>